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F6C2E1-D324-4A48-BB4D-E9D97A29FE80}" v="9" dt="2021-07-30T14:17:47.8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359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opher Sjöwall" userId="19161b2c-e6b5-421c-acee-44f8d60d4e02" providerId="ADAL" clId="{3EF6C2E1-D324-4A48-BB4D-E9D97A29FE80}"/>
    <pc:docChg chg="undo custSel modSld">
      <pc:chgData name="Christopher Sjöwall" userId="19161b2c-e6b5-421c-acee-44f8d60d4e02" providerId="ADAL" clId="{3EF6C2E1-D324-4A48-BB4D-E9D97A29FE80}" dt="2021-07-30T14:18:01.928" v="428" actId="1035"/>
      <pc:docMkLst>
        <pc:docMk/>
      </pc:docMkLst>
      <pc:sldChg chg="addSp delSp modSp mod">
        <pc:chgData name="Christopher Sjöwall" userId="19161b2c-e6b5-421c-acee-44f8d60d4e02" providerId="ADAL" clId="{3EF6C2E1-D324-4A48-BB4D-E9D97A29FE80}" dt="2021-07-30T14:18:01.928" v="428" actId="1035"/>
        <pc:sldMkLst>
          <pc:docMk/>
          <pc:sldMk cId="2087246386" sldId="256"/>
        </pc:sldMkLst>
        <pc:spChg chg="mod">
          <ac:chgData name="Christopher Sjöwall" userId="19161b2c-e6b5-421c-acee-44f8d60d4e02" providerId="ADAL" clId="{3EF6C2E1-D324-4A48-BB4D-E9D97A29FE80}" dt="2021-07-30T14:11:19.135" v="352" actId="6549"/>
          <ac:spMkLst>
            <pc:docMk/>
            <pc:sldMk cId="2087246386" sldId="256"/>
            <ac:spMk id="16" creationId="{8F9A17E9-A84A-4B61-AAF9-5D3A97EBE2F0}"/>
          </ac:spMkLst>
        </pc:spChg>
        <pc:spChg chg="mod">
          <ac:chgData name="Christopher Sjöwall" userId="19161b2c-e6b5-421c-acee-44f8d60d4e02" providerId="ADAL" clId="{3EF6C2E1-D324-4A48-BB4D-E9D97A29FE80}" dt="2021-07-30T14:14:28.404" v="395" actId="164"/>
          <ac:spMkLst>
            <pc:docMk/>
            <pc:sldMk cId="2087246386" sldId="256"/>
            <ac:spMk id="23" creationId="{69B227AC-6082-41B4-9164-C76F4F2B1593}"/>
          </ac:spMkLst>
        </pc:spChg>
        <pc:spChg chg="mod">
          <ac:chgData name="Christopher Sjöwall" userId="19161b2c-e6b5-421c-acee-44f8d60d4e02" providerId="ADAL" clId="{3EF6C2E1-D324-4A48-BB4D-E9D97A29FE80}" dt="2021-07-30T14:14:28.404" v="395" actId="164"/>
          <ac:spMkLst>
            <pc:docMk/>
            <pc:sldMk cId="2087246386" sldId="256"/>
            <ac:spMk id="25" creationId="{116EF6C9-3AC6-4158-B2AA-739606DCDD52}"/>
          </ac:spMkLst>
        </pc:spChg>
        <pc:spChg chg="mod topLvl">
          <ac:chgData name="Christopher Sjöwall" userId="19161b2c-e6b5-421c-acee-44f8d60d4e02" providerId="ADAL" clId="{3EF6C2E1-D324-4A48-BB4D-E9D97A29FE80}" dt="2021-07-30T14:17:47.881" v="425" actId="164"/>
          <ac:spMkLst>
            <pc:docMk/>
            <pc:sldMk cId="2087246386" sldId="256"/>
            <ac:spMk id="28" creationId="{36E35B2F-AD0B-4D05-8F93-7A86AE1FF9AC}"/>
          </ac:spMkLst>
        </pc:spChg>
        <pc:spChg chg="mod topLvl">
          <ac:chgData name="Christopher Sjöwall" userId="19161b2c-e6b5-421c-acee-44f8d60d4e02" providerId="ADAL" clId="{3EF6C2E1-D324-4A48-BB4D-E9D97A29FE80}" dt="2021-07-30T14:17:47.881" v="425" actId="164"/>
          <ac:spMkLst>
            <pc:docMk/>
            <pc:sldMk cId="2087246386" sldId="256"/>
            <ac:spMk id="29" creationId="{32AAB2ED-A1BE-45A9-80D1-EB9F645A1D81}"/>
          </ac:spMkLst>
        </pc:spChg>
        <pc:spChg chg="add mod">
          <ac:chgData name="Christopher Sjöwall" userId="19161b2c-e6b5-421c-acee-44f8d60d4e02" providerId="ADAL" clId="{3EF6C2E1-D324-4A48-BB4D-E9D97A29FE80}" dt="2021-07-30T14:15:56.106" v="421" actId="6549"/>
          <ac:spMkLst>
            <pc:docMk/>
            <pc:sldMk cId="2087246386" sldId="256"/>
            <ac:spMk id="32" creationId="{204AD3BD-8A3E-427F-BB27-B01CFAA752E4}"/>
          </ac:spMkLst>
        </pc:spChg>
        <pc:spChg chg="add mod">
          <ac:chgData name="Christopher Sjöwall" userId="19161b2c-e6b5-421c-acee-44f8d60d4e02" providerId="ADAL" clId="{3EF6C2E1-D324-4A48-BB4D-E9D97A29FE80}" dt="2021-07-30T14:12:52.632" v="357" actId="164"/>
          <ac:spMkLst>
            <pc:docMk/>
            <pc:sldMk cId="2087246386" sldId="256"/>
            <ac:spMk id="36" creationId="{D7EE4A71-3583-4F13-95E8-DBD4C8FC759D}"/>
          </ac:spMkLst>
        </pc:spChg>
        <pc:spChg chg="add mod">
          <ac:chgData name="Christopher Sjöwall" userId="19161b2c-e6b5-421c-acee-44f8d60d4e02" providerId="ADAL" clId="{3EF6C2E1-D324-4A48-BB4D-E9D97A29FE80}" dt="2021-07-30T14:12:52.632" v="357" actId="164"/>
          <ac:spMkLst>
            <pc:docMk/>
            <pc:sldMk cId="2087246386" sldId="256"/>
            <ac:spMk id="37" creationId="{ED4E0A90-3A98-4D0D-9B4A-76CC495432E1}"/>
          </ac:spMkLst>
        </pc:spChg>
        <pc:grpChg chg="del ord">
          <ac:chgData name="Christopher Sjöwall" userId="19161b2c-e6b5-421c-acee-44f8d60d4e02" providerId="ADAL" clId="{3EF6C2E1-D324-4A48-BB4D-E9D97A29FE80}" dt="2021-07-30T14:13:50.404" v="390" actId="165"/>
          <ac:grpSpMkLst>
            <pc:docMk/>
            <pc:sldMk cId="2087246386" sldId="256"/>
            <ac:grpSpMk id="17" creationId="{D3326D52-7282-4132-A96D-7700F261CDC6}"/>
          </ac:grpSpMkLst>
        </pc:grpChg>
        <pc:grpChg chg="del mod ord topLvl">
          <ac:chgData name="Christopher Sjöwall" userId="19161b2c-e6b5-421c-acee-44f8d60d4e02" providerId="ADAL" clId="{3EF6C2E1-D324-4A48-BB4D-E9D97A29FE80}" dt="2021-07-30T14:17:09.365" v="423" actId="165"/>
          <ac:grpSpMkLst>
            <pc:docMk/>
            <pc:sldMk cId="2087246386" sldId="256"/>
            <ac:grpSpMk id="21" creationId="{4C26ED50-93E3-40B3-9D6B-E0724C008750}"/>
          </ac:grpSpMkLst>
        </pc:grpChg>
        <pc:grpChg chg="add mod">
          <ac:chgData name="Christopher Sjöwall" userId="19161b2c-e6b5-421c-acee-44f8d60d4e02" providerId="ADAL" clId="{3EF6C2E1-D324-4A48-BB4D-E9D97A29FE80}" dt="2021-07-30T14:12:52.632" v="357" actId="164"/>
          <ac:grpSpMkLst>
            <pc:docMk/>
            <pc:sldMk cId="2087246386" sldId="256"/>
            <ac:grpSpMk id="33" creationId="{89ED577F-32D4-45AF-A29E-B4E91DD7EC72}"/>
          </ac:grpSpMkLst>
        </pc:grpChg>
        <pc:grpChg chg="add mod">
          <ac:chgData name="Christopher Sjöwall" userId="19161b2c-e6b5-421c-acee-44f8d60d4e02" providerId="ADAL" clId="{3EF6C2E1-D324-4A48-BB4D-E9D97A29FE80}" dt="2021-07-30T14:12:56.527" v="370" actId="1036"/>
          <ac:grpSpMkLst>
            <pc:docMk/>
            <pc:sldMk cId="2087246386" sldId="256"/>
            <ac:grpSpMk id="38" creationId="{ED2CA72E-9762-4793-A1CD-26CE9B06FFA3}"/>
          </ac:grpSpMkLst>
        </pc:grpChg>
        <pc:grpChg chg="add del mod ord">
          <ac:chgData name="Christopher Sjöwall" userId="19161b2c-e6b5-421c-acee-44f8d60d4e02" providerId="ADAL" clId="{3EF6C2E1-D324-4A48-BB4D-E9D97A29FE80}" dt="2021-07-30T14:17:03.360" v="422" actId="165"/>
          <ac:grpSpMkLst>
            <pc:docMk/>
            <pc:sldMk cId="2087246386" sldId="256"/>
            <ac:grpSpMk id="39" creationId="{BD881390-E0CB-461C-87A2-389366517786}"/>
          </ac:grpSpMkLst>
        </pc:grpChg>
        <pc:grpChg chg="add mod">
          <ac:chgData name="Christopher Sjöwall" userId="19161b2c-e6b5-421c-acee-44f8d60d4e02" providerId="ADAL" clId="{3EF6C2E1-D324-4A48-BB4D-E9D97A29FE80}" dt="2021-07-30T14:14:30.744" v="399" actId="1035"/>
          <ac:grpSpMkLst>
            <pc:docMk/>
            <pc:sldMk cId="2087246386" sldId="256"/>
            <ac:grpSpMk id="40" creationId="{85B2EFAD-6A98-462D-8419-3EE58B72A9E1}"/>
          </ac:grpSpMkLst>
        </pc:grpChg>
        <pc:grpChg chg="add mod">
          <ac:chgData name="Christopher Sjöwall" userId="19161b2c-e6b5-421c-acee-44f8d60d4e02" providerId="ADAL" clId="{3EF6C2E1-D324-4A48-BB4D-E9D97A29FE80}" dt="2021-07-30T14:18:01.928" v="428" actId="1035"/>
          <ac:grpSpMkLst>
            <pc:docMk/>
            <pc:sldMk cId="2087246386" sldId="256"/>
            <ac:grpSpMk id="41" creationId="{CE26A2F6-D9DB-44C9-90EC-C6C14F84F9EF}"/>
          </ac:grpSpMkLst>
        </pc:grpChg>
        <pc:picChg chg="mod topLvl">
          <ac:chgData name="Christopher Sjöwall" userId="19161b2c-e6b5-421c-acee-44f8d60d4e02" providerId="ADAL" clId="{3EF6C2E1-D324-4A48-BB4D-E9D97A29FE80}" dt="2021-07-30T14:14:28.404" v="395" actId="164"/>
          <ac:picMkLst>
            <pc:docMk/>
            <pc:sldMk cId="2087246386" sldId="256"/>
            <ac:picMk id="5" creationId="{8A52A376-0E5E-466F-B943-0AB37E40FA05}"/>
          </ac:picMkLst>
        </pc:picChg>
        <pc:picChg chg="mod ord topLvl">
          <ac:chgData name="Christopher Sjöwall" userId="19161b2c-e6b5-421c-acee-44f8d60d4e02" providerId="ADAL" clId="{3EF6C2E1-D324-4A48-BB4D-E9D97A29FE80}" dt="2021-07-30T14:14:28.404" v="395" actId="164"/>
          <ac:picMkLst>
            <pc:docMk/>
            <pc:sldMk cId="2087246386" sldId="256"/>
            <ac:picMk id="7" creationId="{001026C0-2501-4D5B-9733-BED2B1BBE62E}"/>
          </ac:picMkLst>
        </pc:picChg>
        <pc:picChg chg="mod topLvl modCrop">
          <ac:chgData name="Christopher Sjöwall" userId="19161b2c-e6b5-421c-acee-44f8d60d4e02" providerId="ADAL" clId="{3EF6C2E1-D324-4A48-BB4D-E9D97A29FE80}" dt="2021-07-30T14:17:47.881" v="425" actId="164"/>
          <ac:picMkLst>
            <pc:docMk/>
            <pc:sldMk cId="2087246386" sldId="256"/>
            <ac:picMk id="11" creationId="{7BA52D6F-E904-4708-8623-9CEE40C714F7}"/>
          </ac:picMkLst>
        </pc:picChg>
        <pc:picChg chg="mod topLvl">
          <ac:chgData name="Christopher Sjöwall" userId="19161b2c-e6b5-421c-acee-44f8d60d4e02" providerId="ADAL" clId="{3EF6C2E1-D324-4A48-BB4D-E9D97A29FE80}" dt="2021-07-30T14:17:47.881" v="425" actId="164"/>
          <ac:picMkLst>
            <pc:docMk/>
            <pc:sldMk cId="2087246386" sldId="256"/>
            <ac:picMk id="20" creationId="{5A839456-E72F-4587-8E16-A7D398C45F80}"/>
          </ac:picMkLst>
        </pc:picChg>
        <pc:picChg chg="mod">
          <ac:chgData name="Christopher Sjöwall" userId="19161b2c-e6b5-421c-acee-44f8d60d4e02" providerId="ADAL" clId="{3EF6C2E1-D324-4A48-BB4D-E9D97A29FE80}" dt="2021-07-30T14:12:48.500" v="356" actId="571"/>
          <ac:picMkLst>
            <pc:docMk/>
            <pc:sldMk cId="2087246386" sldId="256"/>
            <ac:picMk id="34" creationId="{445EA204-3C1D-4D16-9040-DB985A858CA2}"/>
          </ac:picMkLst>
        </pc:picChg>
        <pc:picChg chg="mod">
          <ac:chgData name="Christopher Sjöwall" userId="19161b2c-e6b5-421c-acee-44f8d60d4e02" providerId="ADAL" clId="{3EF6C2E1-D324-4A48-BB4D-E9D97A29FE80}" dt="2021-07-30T14:12:48.500" v="356" actId="571"/>
          <ac:picMkLst>
            <pc:docMk/>
            <pc:sldMk cId="2087246386" sldId="256"/>
            <ac:picMk id="35" creationId="{F575AF91-D0D0-49B6-A2A0-06BB14B9C78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08103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15267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23749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2654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06275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8823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80662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45088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56229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1089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8722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3B244-298C-4EE1-AE3C-2A5E11FF8603}" type="datetimeFigureOut">
              <a:rPr lang="sv-SE" smtClean="0"/>
              <a:t>2021-07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CD1BB-CF47-44F8-B343-9C0CFF084F7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13371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ruta 15">
            <a:extLst>
              <a:ext uri="{FF2B5EF4-FFF2-40B4-BE49-F238E27FC236}">
                <a16:creationId xmlns:a16="http://schemas.microsoft.com/office/drawing/2014/main" id="{8F9A17E9-A84A-4B61-AAF9-5D3A97EBE2F0}"/>
              </a:ext>
            </a:extLst>
          </p:cNvPr>
          <p:cNvSpPr txBox="1"/>
          <p:nvPr/>
        </p:nvSpPr>
        <p:spPr>
          <a:xfrm>
            <a:off x="474920" y="219740"/>
            <a:ext cx="364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Supplementary Figure </a:t>
            </a:r>
            <a:r>
              <a:rPr lang="en-US" sz="1800" b="1" dirty="0" smtClean="0">
                <a:effectLst/>
                <a:ea typeface="Calibri" panose="020F0502020204030204" pitchFamily="34" charset="0"/>
              </a:rPr>
              <a:t>2</a:t>
            </a:r>
            <a:endParaRPr lang="sv-SE" dirty="0"/>
          </a:p>
        </p:txBody>
      </p:sp>
      <p:sp>
        <p:nvSpPr>
          <p:cNvPr id="28" name="textruta 27">
            <a:extLst>
              <a:ext uri="{FF2B5EF4-FFF2-40B4-BE49-F238E27FC236}">
                <a16:creationId xmlns:a16="http://schemas.microsoft.com/office/drawing/2014/main" id="{36E35B2F-AD0B-4D05-8F93-7A86AE1FF9AC}"/>
              </a:ext>
            </a:extLst>
          </p:cNvPr>
          <p:cNvSpPr txBox="1"/>
          <p:nvPr/>
        </p:nvSpPr>
        <p:spPr>
          <a:xfrm>
            <a:off x="573219" y="8766121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C)</a:t>
            </a:r>
            <a:endParaRPr lang="sv-SE" dirty="0"/>
          </a:p>
        </p:txBody>
      </p:sp>
      <p:sp>
        <p:nvSpPr>
          <p:cNvPr id="23" name="textruta 22">
            <a:extLst>
              <a:ext uri="{FF2B5EF4-FFF2-40B4-BE49-F238E27FC236}">
                <a16:creationId xmlns:a16="http://schemas.microsoft.com/office/drawing/2014/main" id="{69B227AC-6082-41B4-9164-C76F4F2B1593}"/>
              </a:ext>
            </a:extLst>
          </p:cNvPr>
          <p:cNvSpPr txBox="1"/>
          <p:nvPr/>
        </p:nvSpPr>
        <p:spPr>
          <a:xfrm>
            <a:off x="554169" y="879832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A)</a:t>
            </a:r>
            <a:endParaRPr lang="sv-SE" dirty="0"/>
          </a:p>
        </p:txBody>
      </p:sp>
      <p:sp>
        <p:nvSpPr>
          <p:cNvPr id="25" name="textruta 24">
            <a:extLst>
              <a:ext uri="{FF2B5EF4-FFF2-40B4-BE49-F238E27FC236}">
                <a16:creationId xmlns:a16="http://schemas.microsoft.com/office/drawing/2014/main" id="{116EF6C9-3AC6-4158-B2AA-739606DCDD52}"/>
              </a:ext>
            </a:extLst>
          </p:cNvPr>
          <p:cNvSpPr txBox="1"/>
          <p:nvPr/>
        </p:nvSpPr>
        <p:spPr>
          <a:xfrm>
            <a:off x="563693" y="4702027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B)</a:t>
            </a:r>
            <a:endParaRPr lang="sv-SE" dirty="0"/>
          </a:p>
        </p:txBody>
      </p:sp>
      <p:sp>
        <p:nvSpPr>
          <p:cNvPr id="32" name="textruta 31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5907" y="851346"/>
            <a:ext cx="2822234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-SARS-CoV-2 IgA. The ratio was calculated according to the instructions provided in the kit. Shown here are the representativ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-pandemic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pandemic samples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5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LE patients along with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ositiv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negativ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s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vided in th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t. W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so included a negativ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ich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s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lected before the pandemic and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lank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906" y="880374"/>
            <a:ext cx="3429000" cy="3158966"/>
          </a:xfrm>
          <a:prstGeom prst="rect">
            <a:avLst/>
          </a:prstGeom>
        </p:spPr>
      </p:pic>
      <p:pic>
        <p:nvPicPr>
          <p:cNvPr id="27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026" y="4702027"/>
            <a:ext cx="3321844" cy="3120390"/>
          </a:xfrm>
          <a:prstGeom prst="rect">
            <a:avLst/>
          </a:prstGeom>
        </p:spPr>
      </p:pic>
      <p:sp>
        <p:nvSpPr>
          <p:cNvPr id="39" name="textruta 38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5907" y="4708971"/>
            <a:ext cx="2822234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-SARS-CoV-2 IgA. The ratio was calculated according to the instructions provided in the kit. Shown here are the representative pre-pandemic and pandemic samples from 5 SLE patients along with the positive and negative controls provided in the kit. We also included a negative sample, which was collected before the pandemic and the blank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3219" y="8766121"/>
            <a:ext cx="3321844" cy="3120390"/>
          </a:xfrm>
          <a:prstGeom prst="rect">
            <a:avLst/>
          </a:prstGeom>
        </p:spPr>
      </p:pic>
      <p:sp>
        <p:nvSpPr>
          <p:cNvPr id="43" name="textruta 42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5907" y="8785671"/>
            <a:ext cx="2822234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-SARS-CoV-2 IgA. The ratio was calculated according to the instructions provided in the kit. Shown here are the representative pre-pandemic and pandemic samples from 5 SLE patients along with the positive and negative controls provided in the kit. We also included a negative sample, which was collected before the pandemic and the blank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246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id="{32AAB2ED-A1BE-45A9-80D1-EB9F645A1D81}"/>
              </a:ext>
            </a:extLst>
          </p:cNvPr>
          <p:cNvSpPr txBox="1"/>
          <p:nvPr/>
        </p:nvSpPr>
        <p:spPr>
          <a:xfrm>
            <a:off x="364624" y="435437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D)</a:t>
            </a:r>
            <a:endParaRPr lang="sv-SE" dirty="0"/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687659C7-F731-45D5-BBC8-051FB8B62804}"/>
              </a:ext>
            </a:extLst>
          </p:cNvPr>
          <p:cNvSpPr txBox="1"/>
          <p:nvPr/>
        </p:nvSpPr>
        <p:spPr>
          <a:xfrm>
            <a:off x="393199" y="4197812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E)</a:t>
            </a:r>
            <a:endParaRPr lang="sv-SE" dirty="0"/>
          </a:p>
        </p:txBody>
      </p:sp>
      <p:sp>
        <p:nvSpPr>
          <p:cNvPr id="6" name="textruta 5">
            <a:extLst>
              <a:ext uri="{FF2B5EF4-FFF2-40B4-BE49-F238E27FC236}">
                <a16:creationId xmlns:a16="http://schemas.microsoft.com/office/drawing/2014/main" id="{190392FF-944A-490B-9F3A-382C2A56EB75}"/>
              </a:ext>
            </a:extLst>
          </p:cNvPr>
          <p:cNvSpPr txBox="1"/>
          <p:nvPr/>
        </p:nvSpPr>
        <p:spPr>
          <a:xfrm>
            <a:off x="393199" y="8091394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ea typeface="Calibri" panose="020F0502020204030204" pitchFamily="34" charset="0"/>
              </a:rPr>
              <a:t>F)</a:t>
            </a:r>
            <a:endParaRPr lang="sv-SE" dirty="0"/>
          </a:p>
        </p:txBody>
      </p:sp>
      <p:sp>
        <p:nvSpPr>
          <p:cNvPr id="7" name="textruta 6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5907" y="508446"/>
            <a:ext cx="2822234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Anti-SARS-CoV-2 IgA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ratio was calculated according to the instructions provided in the kit. Shown here are the representative pre-pandemic and pandemic samples from 5 SLE patients along with the positive and negative controls provided in the kit. We also included a negative sample, which was collected before the pandemic and the blank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4920" y="453679"/>
            <a:ext cx="3321844" cy="3120390"/>
          </a:xfrm>
          <a:prstGeom prst="rect">
            <a:avLst/>
          </a:prstGeom>
        </p:spPr>
      </p:pic>
      <p:pic>
        <p:nvPicPr>
          <p:cNvPr id="10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920" y="4197812"/>
            <a:ext cx="3321844" cy="3120390"/>
          </a:xfrm>
          <a:prstGeom prst="rect">
            <a:avLst/>
          </a:prstGeom>
        </p:spPr>
      </p:pic>
      <p:sp>
        <p:nvSpPr>
          <p:cNvPr id="11" name="textruta 10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3391" y="4197812"/>
            <a:ext cx="2822234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Anti-SARS-CoV-2 IgA. The ratio was calculated according to the instructions provided in the kit. Shown here are the representative pre-pandemic and pandemic samples from 5 SLE patients along with the positive and negative controls provided in the kit. We also included a negative sample, which was collected before the pandemic and the blank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0747" y="8110444"/>
            <a:ext cx="3373279" cy="3266123"/>
          </a:xfrm>
          <a:prstGeom prst="rect">
            <a:avLst/>
          </a:prstGeom>
        </p:spPr>
      </p:pic>
      <p:sp>
        <p:nvSpPr>
          <p:cNvPr id="13" name="textruta 12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3391" y="8112587"/>
            <a:ext cx="2822234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Anti-SARS-CoV-2 IgA. Th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tio was calculated according to the instructions provided in the kit. Shown here are the representative pre-pandemic and pandemic samples from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LE patients along with the positive and negative controls provided in the kit. We also included a negative sample, which was collected before the pandemic and the blank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8581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id="{32AAB2ED-A1BE-45A9-80D1-EB9F645A1D81}"/>
              </a:ext>
            </a:extLst>
          </p:cNvPr>
          <p:cNvSpPr txBox="1"/>
          <p:nvPr/>
        </p:nvSpPr>
        <p:spPr>
          <a:xfrm>
            <a:off x="364624" y="435437"/>
            <a:ext cx="41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>
                <a:effectLst/>
                <a:ea typeface="Calibri" panose="020F0502020204030204" pitchFamily="34" charset="0"/>
              </a:rPr>
              <a:t>G)</a:t>
            </a:r>
            <a:endParaRPr lang="sv-SE" dirty="0"/>
          </a:p>
        </p:txBody>
      </p:sp>
      <p:sp>
        <p:nvSpPr>
          <p:cNvPr id="7" name="textruta 6">
            <a:extLst>
              <a:ext uri="{FF2B5EF4-FFF2-40B4-BE49-F238E27FC236}">
                <a16:creationId xmlns:a16="http://schemas.microsoft.com/office/drawing/2014/main" id="{204AD3BD-8A3E-427F-BB27-B01CFAA752E4}"/>
              </a:ext>
            </a:extLst>
          </p:cNvPr>
          <p:cNvSpPr txBox="1"/>
          <p:nvPr/>
        </p:nvSpPr>
        <p:spPr>
          <a:xfrm>
            <a:off x="4085907" y="508446"/>
            <a:ext cx="2822234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UROIMMU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-SARS-CoV-2 IgA. The ratio was calculated according to the instructions provided in the kit. Shown here are the representativ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s from 2 SARS-CoV-2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R-positive patients (not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SLE study population)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serum samples were collected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y 0,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4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28 (sinc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onset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symptoms), along with the positive and negativ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s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vided in the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t. W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so included a negative sample which were collected before the pandemic and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lank.</a:t>
            </a:r>
            <a:endParaRPr lang="en-US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2172" y="435437"/>
            <a:ext cx="3296126" cy="31761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0980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</TotalTime>
  <Words>474</Words>
  <Application>Microsoft Office PowerPoint</Application>
  <PresentationFormat>Bredbild</PresentationFormat>
  <Paragraphs>15</Paragraphs>
  <Slides>3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-tema</vt:lpstr>
      <vt:lpstr>PowerPoint-presentation</vt:lpstr>
      <vt:lpstr>PowerPoint-presentation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Christopher Sjöwall</dc:creator>
  <cp:lastModifiedBy>Sjöwall Christoffer</cp:lastModifiedBy>
  <cp:revision>7</cp:revision>
  <dcterms:created xsi:type="dcterms:W3CDTF">2021-07-30T13:34:32Z</dcterms:created>
  <dcterms:modified xsi:type="dcterms:W3CDTF">2021-07-30T20:30:08Z</dcterms:modified>
</cp:coreProperties>
</file>